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 showGuides="1">
      <p:cViewPr varScale="1">
        <p:scale>
          <a:sx n="72" d="100"/>
          <a:sy n="72" d="100"/>
        </p:scale>
        <p:origin x="2634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nas1.stockage.inra.fr\rennes-pegase-users$\root\fgondret\mesdocuments\Participation%20vie%20commune\demandes%20financement\Europe\PigWeb\Article\article%20glucose\Soumission%20ANIMAL\PigWeb%20-%20Inrae1%20-%20Glucose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PigWeb - Inrae1 - Glucose'!$E$1</c:f>
              <c:strCache>
                <c:ptCount val="1"/>
                <c:pt idx="0">
                  <c:v>smoothed_sensor_glucos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PigWeb - Inrae1 - Glucose'!$D$2:$D$211</c:f>
              <c:numCache>
                <c:formatCode>General</c:formatCode>
                <c:ptCount val="210"/>
                <c:pt idx="0">
                  <c:v>91.414050000000003</c:v>
                </c:pt>
                <c:pt idx="1">
                  <c:v>84.103949999999998</c:v>
                </c:pt>
                <c:pt idx="2">
                  <c:v>110.30745</c:v>
                </c:pt>
                <c:pt idx="3">
                  <c:v>91.921999999999997</c:v>
                </c:pt>
                <c:pt idx="4">
                  <c:v>96.442949999999996</c:v>
                </c:pt>
                <c:pt idx="5">
                  <c:v>97.892700000000005</c:v>
                </c:pt>
                <c:pt idx="6">
                  <c:v>101.45225000000001</c:v>
                </c:pt>
                <c:pt idx="7">
                  <c:v>85.414100000000005</c:v>
                </c:pt>
                <c:pt idx="8">
                  <c:v>96.704949999999997</c:v>
                </c:pt>
                <c:pt idx="9">
                  <c:v>90.767049999999998</c:v>
                </c:pt>
                <c:pt idx="10">
                  <c:v>96.802549999999997</c:v>
                </c:pt>
                <c:pt idx="11">
                  <c:v>89.142150000000001</c:v>
                </c:pt>
                <c:pt idx="12">
                  <c:v>99.188299999999998</c:v>
                </c:pt>
                <c:pt idx="13">
                  <c:v>94.414450000000002</c:v>
                </c:pt>
                <c:pt idx="14">
                  <c:v>92.602000000000004</c:v>
                </c:pt>
                <c:pt idx="15">
                  <c:v>91.358099999999993</c:v>
                </c:pt>
                <c:pt idx="16">
                  <c:v>86.050299999999993</c:v>
                </c:pt>
                <c:pt idx="17">
                  <c:v>95.565700000000007</c:v>
                </c:pt>
                <c:pt idx="18">
                  <c:v>114.7187</c:v>
                </c:pt>
                <c:pt idx="19">
                  <c:v>126.45005</c:v>
                </c:pt>
                <c:pt idx="20">
                  <c:v>116.9521</c:v>
                </c:pt>
                <c:pt idx="21">
                  <c:v>123.0617</c:v>
                </c:pt>
                <c:pt idx="22">
                  <c:v>101.98824999999999</c:v>
                </c:pt>
                <c:pt idx="23">
                  <c:v>97.473399999999998</c:v>
                </c:pt>
                <c:pt idx="24">
                  <c:v>93.685249999999996</c:v>
                </c:pt>
                <c:pt idx="25">
                  <c:v>99.418199999999999</c:v>
                </c:pt>
                <c:pt idx="26">
                  <c:v>100.167</c:v>
                </c:pt>
                <c:pt idx="27">
                  <c:v>96.176199999999994</c:v>
                </c:pt>
                <c:pt idx="28">
                  <c:v>92.514449999999997</c:v>
                </c:pt>
                <c:pt idx="29">
                  <c:v>92.452500000000001</c:v>
                </c:pt>
                <c:pt idx="30">
                  <c:v>97.127565000000004</c:v>
                </c:pt>
                <c:pt idx="31">
                  <c:v>97.992225000000005</c:v>
                </c:pt>
                <c:pt idx="32">
                  <c:v>106.6135</c:v>
                </c:pt>
                <c:pt idx="33">
                  <c:v>114.89879999999999</c:v>
                </c:pt>
                <c:pt idx="34">
                  <c:v>105.4674</c:v>
                </c:pt>
                <c:pt idx="35">
                  <c:v>92.891334999999998</c:v>
                </c:pt>
                <c:pt idx="36">
                  <c:v>93.389489999999995</c:v>
                </c:pt>
                <c:pt idx="37">
                  <c:v>92.228665000000007</c:v>
                </c:pt>
                <c:pt idx="38">
                  <c:v>82.890434999999997</c:v>
                </c:pt>
                <c:pt idx="39">
                  <c:v>90.311869999999999</c:v>
                </c:pt>
                <c:pt idx="40">
                  <c:v>93.372645000000006</c:v>
                </c:pt>
                <c:pt idx="41">
                  <c:v>97.271500000000003</c:v>
                </c:pt>
                <c:pt idx="42">
                  <c:v>91.438495000000003</c:v>
                </c:pt>
                <c:pt idx="43">
                  <c:v>97.723335000000006</c:v>
                </c:pt>
                <c:pt idx="44">
                  <c:v>93.894024999999999</c:v>
                </c:pt>
                <c:pt idx="45">
                  <c:v>88.842825000000005</c:v>
                </c:pt>
                <c:pt idx="46">
                  <c:v>87.615184999999997</c:v>
                </c:pt>
                <c:pt idx="47">
                  <c:v>92.440034999999995</c:v>
                </c:pt>
                <c:pt idx="48">
                  <c:v>92.724519999999998</c:v>
                </c:pt>
                <c:pt idx="49">
                  <c:v>96.522000000000006</c:v>
                </c:pt>
                <c:pt idx="50">
                  <c:v>98.263980000000004</c:v>
                </c:pt>
                <c:pt idx="51">
                  <c:v>91.626395000000002</c:v>
                </c:pt>
                <c:pt idx="52">
                  <c:v>89.498835</c:v>
                </c:pt>
                <c:pt idx="53">
                  <c:v>97.782529999999994</c:v>
                </c:pt>
                <c:pt idx="54">
                  <c:v>91.490975000000006</c:v>
                </c:pt>
                <c:pt idx="55">
                  <c:v>93.371960000000001</c:v>
                </c:pt>
                <c:pt idx="56">
                  <c:v>90.203969999999998</c:v>
                </c:pt>
                <c:pt idx="57">
                  <c:v>96.456239999999994</c:v>
                </c:pt>
                <c:pt idx="58">
                  <c:v>100.67815</c:v>
                </c:pt>
                <c:pt idx="59">
                  <c:v>94.639750000000006</c:v>
                </c:pt>
                <c:pt idx="60">
                  <c:v>90.611469999999997</c:v>
                </c:pt>
                <c:pt idx="61">
                  <c:v>90.230395000000001</c:v>
                </c:pt>
                <c:pt idx="62">
                  <c:v>102.6093</c:v>
                </c:pt>
                <c:pt idx="63">
                  <c:v>117.01935</c:v>
                </c:pt>
                <c:pt idx="64">
                  <c:v>120.40295</c:v>
                </c:pt>
                <c:pt idx="65">
                  <c:v>121.5647</c:v>
                </c:pt>
                <c:pt idx="66">
                  <c:v>112.8185</c:v>
                </c:pt>
                <c:pt idx="67">
                  <c:v>84.425205000000005</c:v>
                </c:pt>
                <c:pt idx="68">
                  <c:v>89.00076</c:v>
                </c:pt>
                <c:pt idx="69">
                  <c:v>98.669454999999999</c:v>
                </c:pt>
                <c:pt idx="70">
                  <c:v>86.457515000000001</c:v>
                </c:pt>
                <c:pt idx="71">
                  <c:v>100.84985</c:v>
                </c:pt>
                <c:pt idx="72">
                  <c:v>88.586190000000002</c:v>
                </c:pt>
                <c:pt idx="73">
                  <c:v>95.279015000000001</c:v>
                </c:pt>
                <c:pt idx="74">
                  <c:v>88.748495000000005</c:v>
                </c:pt>
                <c:pt idx="75">
                  <c:v>90.416894999999997</c:v>
                </c:pt>
                <c:pt idx="76">
                  <c:v>96.793549999999996</c:v>
                </c:pt>
                <c:pt idx="77">
                  <c:v>101.6832</c:v>
                </c:pt>
                <c:pt idx="78">
                  <c:v>108.54089999999999</c:v>
                </c:pt>
                <c:pt idx="79">
                  <c:v>108.0355</c:v>
                </c:pt>
                <c:pt idx="80">
                  <c:v>112.13135</c:v>
                </c:pt>
                <c:pt idx="81">
                  <c:v>109.74655</c:v>
                </c:pt>
                <c:pt idx="82">
                  <c:v>93.710229999999996</c:v>
                </c:pt>
                <c:pt idx="83">
                  <c:v>95.528914999999998</c:v>
                </c:pt>
                <c:pt idx="84">
                  <c:v>103.0012</c:v>
                </c:pt>
                <c:pt idx="85">
                  <c:v>101.70365</c:v>
                </c:pt>
                <c:pt idx="86">
                  <c:v>105.26220000000001</c:v>
                </c:pt>
                <c:pt idx="87">
                  <c:v>106.27419999999999</c:v>
                </c:pt>
                <c:pt idx="88">
                  <c:v>87.163875000000004</c:v>
                </c:pt>
                <c:pt idx="89">
                  <c:v>101.0979</c:v>
                </c:pt>
                <c:pt idx="90">
                  <c:v>95.072209999999998</c:v>
                </c:pt>
                <c:pt idx="91">
                  <c:v>92.837874999999997</c:v>
                </c:pt>
                <c:pt idx="92">
                  <c:v>104.08150000000001</c:v>
                </c:pt>
                <c:pt idx="93">
                  <c:v>126.30005</c:v>
                </c:pt>
                <c:pt idx="94">
                  <c:v>122.11790000000001</c:v>
                </c:pt>
                <c:pt idx="95">
                  <c:v>111.85875</c:v>
                </c:pt>
                <c:pt idx="96">
                  <c:v>102.45435000000001</c:v>
                </c:pt>
                <c:pt idx="97">
                  <c:v>92.402330000000006</c:v>
                </c:pt>
                <c:pt idx="98">
                  <c:v>100.08069999999999</c:v>
                </c:pt>
                <c:pt idx="99">
                  <c:v>96.086775000000003</c:v>
                </c:pt>
                <c:pt idx="100">
                  <c:v>107.5642</c:v>
                </c:pt>
                <c:pt idx="101">
                  <c:v>100.14803499999999</c:v>
                </c:pt>
                <c:pt idx="102">
                  <c:v>100.64704999999999</c:v>
                </c:pt>
                <c:pt idx="103">
                  <c:v>99.872219999999999</c:v>
                </c:pt>
                <c:pt idx="104">
                  <c:v>91.657600000000002</c:v>
                </c:pt>
                <c:pt idx="105">
                  <c:v>86.883399999999995</c:v>
                </c:pt>
                <c:pt idx="106">
                  <c:v>84.703800000000001</c:v>
                </c:pt>
                <c:pt idx="107">
                  <c:v>88.074449999999999</c:v>
                </c:pt>
                <c:pt idx="108">
                  <c:v>86.093649999999997</c:v>
                </c:pt>
                <c:pt idx="109">
                  <c:v>85.661699999999996</c:v>
                </c:pt>
                <c:pt idx="110">
                  <c:v>84.781199999999998</c:v>
                </c:pt>
                <c:pt idx="111">
                  <c:v>89.91825</c:v>
                </c:pt>
                <c:pt idx="112">
                  <c:v>90.212000000000003</c:v>
                </c:pt>
                <c:pt idx="113">
                  <c:v>100.08839999999999</c:v>
                </c:pt>
                <c:pt idx="114">
                  <c:v>91.917249999999996</c:v>
                </c:pt>
                <c:pt idx="115">
                  <c:v>88.665850000000006</c:v>
                </c:pt>
                <c:pt idx="116">
                  <c:v>108.07615</c:v>
                </c:pt>
                <c:pt idx="117">
                  <c:v>99.194749999999999</c:v>
                </c:pt>
                <c:pt idx="118">
                  <c:v>105.50754999999999</c:v>
                </c:pt>
                <c:pt idx="119">
                  <c:v>101.9528</c:v>
                </c:pt>
                <c:pt idx="120">
                  <c:v>98.331900000000005</c:v>
                </c:pt>
                <c:pt idx="121">
                  <c:v>93.069299999999998</c:v>
                </c:pt>
                <c:pt idx="122">
                  <c:v>98.684449999999998</c:v>
                </c:pt>
                <c:pt idx="123">
                  <c:v>98.5184</c:v>
                </c:pt>
                <c:pt idx="124">
                  <c:v>101.84795</c:v>
                </c:pt>
                <c:pt idx="125">
                  <c:v>106.249</c:v>
                </c:pt>
                <c:pt idx="126">
                  <c:v>94.3874</c:v>
                </c:pt>
                <c:pt idx="127">
                  <c:v>90.487499999999997</c:v>
                </c:pt>
                <c:pt idx="128">
                  <c:v>95.713399999999993</c:v>
                </c:pt>
                <c:pt idx="129">
                  <c:v>99.788600000000002</c:v>
                </c:pt>
                <c:pt idx="130">
                  <c:v>98.315150000000003</c:v>
                </c:pt>
                <c:pt idx="131">
                  <c:v>91.140749999999997</c:v>
                </c:pt>
                <c:pt idx="132">
                  <c:v>100.6472</c:v>
                </c:pt>
                <c:pt idx="133">
                  <c:v>84.450199999999995</c:v>
                </c:pt>
                <c:pt idx="134">
                  <c:v>97.925550000000001</c:v>
                </c:pt>
                <c:pt idx="135">
                  <c:v>94.334654999999998</c:v>
                </c:pt>
                <c:pt idx="136">
                  <c:v>77.140725000000003</c:v>
                </c:pt>
                <c:pt idx="137">
                  <c:v>85.993129999999994</c:v>
                </c:pt>
                <c:pt idx="138">
                  <c:v>80.290049999999994</c:v>
                </c:pt>
                <c:pt idx="139">
                  <c:v>75.555610000000001</c:v>
                </c:pt>
                <c:pt idx="140">
                  <c:v>72.647009999999995</c:v>
                </c:pt>
                <c:pt idx="141">
                  <c:v>85.804150000000007</c:v>
                </c:pt>
                <c:pt idx="142">
                  <c:v>86.053455</c:v>
                </c:pt>
                <c:pt idx="143">
                  <c:v>83.546229999999994</c:v>
                </c:pt>
                <c:pt idx="144">
                  <c:v>81.920479999999998</c:v>
                </c:pt>
                <c:pt idx="145">
                  <c:v>95.443049999999999</c:v>
                </c:pt>
                <c:pt idx="146">
                  <c:v>87.259079999999997</c:v>
                </c:pt>
                <c:pt idx="147">
                  <c:v>88.266279999999995</c:v>
                </c:pt>
                <c:pt idx="148">
                  <c:v>76.023624999999996</c:v>
                </c:pt>
                <c:pt idx="149">
                  <c:v>88.060254999999998</c:v>
                </c:pt>
                <c:pt idx="150">
                  <c:v>94.881424999999993</c:v>
                </c:pt>
                <c:pt idx="151">
                  <c:v>91.648354999999995</c:v>
                </c:pt>
                <c:pt idx="152">
                  <c:v>97.468175000000002</c:v>
                </c:pt>
                <c:pt idx="153">
                  <c:v>99.007095000000007</c:v>
                </c:pt>
                <c:pt idx="154">
                  <c:v>93.907089999999997</c:v>
                </c:pt>
                <c:pt idx="155">
                  <c:v>88.803115000000005</c:v>
                </c:pt>
                <c:pt idx="156">
                  <c:v>90.365105</c:v>
                </c:pt>
                <c:pt idx="157">
                  <c:v>97.451234999999997</c:v>
                </c:pt>
                <c:pt idx="158">
                  <c:v>86.699579999999997</c:v>
                </c:pt>
                <c:pt idx="159">
                  <c:v>86.965729999999994</c:v>
                </c:pt>
                <c:pt idx="160">
                  <c:v>90.395444999999995</c:v>
                </c:pt>
                <c:pt idx="161">
                  <c:v>95.021810000000002</c:v>
                </c:pt>
                <c:pt idx="162">
                  <c:v>85.78125</c:v>
                </c:pt>
                <c:pt idx="163">
                  <c:v>93.343024999999997</c:v>
                </c:pt>
                <c:pt idx="164">
                  <c:v>94.240110000000001</c:v>
                </c:pt>
                <c:pt idx="165">
                  <c:v>87.632474999999999</c:v>
                </c:pt>
                <c:pt idx="166">
                  <c:v>77.859845000000007</c:v>
                </c:pt>
                <c:pt idx="167">
                  <c:v>86.198040000000006</c:v>
                </c:pt>
                <c:pt idx="168">
                  <c:v>86.253264999999999</c:v>
                </c:pt>
                <c:pt idx="169">
                  <c:v>91.796904999999995</c:v>
                </c:pt>
                <c:pt idx="170">
                  <c:v>87.637240000000006</c:v>
                </c:pt>
                <c:pt idx="171">
                  <c:v>89.767169999999993</c:v>
                </c:pt>
                <c:pt idx="172">
                  <c:v>86.430475000000001</c:v>
                </c:pt>
                <c:pt idx="173">
                  <c:v>98.850454999999997</c:v>
                </c:pt>
                <c:pt idx="174">
                  <c:v>91.229159999999993</c:v>
                </c:pt>
                <c:pt idx="175">
                  <c:v>85.599435</c:v>
                </c:pt>
                <c:pt idx="176">
                  <c:v>105.34465</c:v>
                </c:pt>
                <c:pt idx="177">
                  <c:v>95.630984999999995</c:v>
                </c:pt>
                <c:pt idx="178">
                  <c:v>97.317965000000001</c:v>
                </c:pt>
                <c:pt idx="179">
                  <c:v>100.85565</c:v>
                </c:pt>
                <c:pt idx="180">
                  <c:v>89.628129999999999</c:v>
                </c:pt>
                <c:pt idx="181">
                  <c:v>85.423659999999998</c:v>
                </c:pt>
                <c:pt idx="182">
                  <c:v>89.963170000000005</c:v>
                </c:pt>
                <c:pt idx="183">
                  <c:v>95.726960000000005</c:v>
                </c:pt>
                <c:pt idx="184">
                  <c:v>91.686094999999995</c:v>
                </c:pt>
                <c:pt idx="185">
                  <c:v>94.132845000000003</c:v>
                </c:pt>
                <c:pt idx="186">
                  <c:v>91.532295000000005</c:v>
                </c:pt>
                <c:pt idx="187">
                  <c:v>87.051460000000006</c:v>
                </c:pt>
                <c:pt idx="188">
                  <c:v>82.624799999999993</c:v>
                </c:pt>
                <c:pt idx="189">
                  <c:v>92.224739999999997</c:v>
                </c:pt>
                <c:pt idx="190">
                  <c:v>102.14175</c:v>
                </c:pt>
                <c:pt idx="191">
                  <c:v>95.506960000000007</c:v>
                </c:pt>
                <c:pt idx="192">
                  <c:v>89.030185000000003</c:v>
                </c:pt>
                <c:pt idx="193">
                  <c:v>95.765569999999997</c:v>
                </c:pt>
                <c:pt idx="194">
                  <c:v>98.530384999999995</c:v>
                </c:pt>
                <c:pt idx="195">
                  <c:v>90.868035000000006</c:v>
                </c:pt>
                <c:pt idx="196">
                  <c:v>85.458550000000002</c:v>
                </c:pt>
                <c:pt idx="197">
                  <c:v>92.244990000000001</c:v>
                </c:pt>
                <c:pt idx="198">
                  <c:v>96.882379999999998</c:v>
                </c:pt>
                <c:pt idx="199">
                  <c:v>89.740899999999996</c:v>
                </c:pt>
                <c:pt idx="200">
                  <c:v>100.46934</c:v>
                </c:pt>
                <c:pt idx="201">
                  <c:v>96.180899999999994</c:v>
                </c:pt>
                <c:pt idx="202">
                  <c:v>87.927445000000006</c:v>
                </c:pt>
                <c:pt idx="203">
                  <c:v>87.638990000000007</c:v>
                </c:pt>
                <c:pt idx="204">
                  <c:v>74.694400000000002</c:v>
                </c:pt>
                <c:pt idx="205">
                  <c:v>88.413780000000003</c:v>
                </c:pt>
                <c:pt idx="206">
                  <c:v>87.944869999999995</c:v>
                </c:pt>
                <c:pt idx="207">
                  <c:v>98.365669999999994</c:v>
                </c:pt>
                <c:pt idx="208">
                  <c:v>99.909305000000003</c:v>
                </c:pt>
                <c:pt idx="209">
                  <c:v>96.547359999999998</c:v>
                </c:pt>
              </c:numCache>
            </c:numRef>
          </c:xVal>
          <c:yVal>
            <c:numRef>
              <c:f>'PigWeb - Inrae1 - Glucose'!$E$2:$E$211</c:f>
              <c:numCache>
                <c:formatCode>General</c:formatCode>
                <c:ptCount val="210"/>
                <c:pt idx="0">
                  <c:v>121.794</c:v>
                </c:pt>
                <c:pt idx="1">
                  <c:v>144.83099999999999</c:v>
                </c:pt>
                <c:pt idx="2">
                  <c:v>154.90899999999999</c:v>
                </c:pt>
                <c:pt idx="3">
                  <c:v>161.22200000000001</c:v>
                </c:pt>
                <c:pt idx="4">
                  <c:v>160.99100000000001</c:v>
                </c:pt>
                <c:pt idx="5">
                  <c:v>157.50700000000001</c:v>
                </c:pt>
                <c:pt idx="6">
                  <c:v>154.24</c:v>
                </c:pt>
                <c:pt idx="7">
                  <c:v>149.07900000000001</c:v>
                </c:pt>
                <c:pt idx="8">
                  <c:v>153.16800000000001</c:v>
                </c:pt>
                <c:pt idx="9">
                  <c:v>158.012</c:v>
                </c:pt>
                <c:pt idx="10">
                  <c:v>155.68299999999999</c:v>
                </c:pt>
                <c:pt idx="11">
                  <c:v>135.55600000000001</c:v>
                </c:pt>
                <c:pt idx="12">
                  <c:v>126.563</c:v>
                </c:pt>
                <c:pt idx="13">
                  <c:v>128.727</c:v>
                </c:pt>
                <c:pt idx="14">
                  <c:v>133.08699999999999</c:v>
                </c:pt>
                <c:pt idx="15">
                  <c:v>127.988</c:v>
                </c:pt>
                <c:pt idx="16">
                  <c:v>146.85900000000001</c:v>
                </c:pt>
                <c:pt idx="17">
                  <c:v>159.23699999999999</c:v>
                </c:pt>
                <c:pt idx="18">
                  <c:v>170.059</c:v>
                </c:pt>
                <c:pt idx="19">
                  <c:v>179.459</c:v>
                </c:pt>
                <c:pt idx="20">
                  <c:v>184.321</c:v>
                </c:pt>
                <c:pt idx="21">
                  <c:v>182.905</c:v>
                </c:pt>
                <c:pt idx="22">
                  <c:v>168.4</c:v>
                </c:pt>
                <c:pt idx="23">
                  <c:v>155.08000000000001</c:v>
                </c:pt>
                <c:pt idx="24">
                  <c:v>152.721</c:v>
                </c:pt>
                <c:pt idx="25">
                  <c:v>148.49799999999999</c:v>
                </c:pt>
                <c:pt idx="26">
                  <c:v>140.31</c:v>
                </c:pt>
                <c:pt idx="27">
                  <c:v>128.72200000000001</c:v>
                </c:pt>
                <c:pt idx="28">
                  <c:v>130.59</c:v>
                </c:pt>
                <c:pt idx="29">
                  <c:v>137.946</c:v>
                </c:pt>
                <c:pt idx="30">
                  <c:v>104.1</c:v>
                </c:pt>
                <c:pt idx="31">
                  <c:v>115.61799999999999</c:v>
                </c:pt>
                <c:pt idx="32">
                  <c:v>119.43300000000001</c:v>
                </c:pt>
                <c:pt idx="33">
                  <c:v>122.376</c:v>
                </c:pt>
                <c:pt idx="34">
                  <c:v>124.337</c:v>
                </c:pt>
                <c:pt idx="35">
                  <c:v>122.214</c:v>
                </c:pt>
                <c:pt idx="36">
                  <c:v>116.363</c:v>
                </c:pt>
                <c:pt idx="37">
                  <c:v>107.867</c:v>
                </c:pt>
                <c:pt idx="38">
                  <c:v>105.377</c:v>
                </c:pt>
                <c:pt idx="39">
                  <c:v>105.38500000000001</c:v>
                </c:pt>
                <c:pt idx="40">
                  <c:v>106.154</c:v>
                </c:pt>
                <c:pt idx="41">
                  <c:v>107.929</c:v>
                </c:pt>
                <c:pt idx="42">
                  <c:v>107.18600000000001</c:v>
                </c:pt>
                <c:pt idx="43">
                  <c:v>103.702</c:v>
                </c:pt>
                <c:pt idx="44">
                  <c:v>101.568</c:v>
                </c:pt>
                <c:pt idx="45">
                  <c:v>120.62</c:v>
                </c:pt>
                <c:pt idx="46">
                  <c:v>129.71700000000001</c:v>
                </c:pt>
                <c:pt idx="47">
                  <c:v>134.12200000000001</c:v>
                </c:pt>
                <c:pt idx="48">
                  <c:v>135.46199999999999</c:v>
                </c:pt>
                <c:pt idx="49">
                  <c:v>135.857</c:v>
                </c:pt>
                <c:pt idx="50">
                  <c:v>136.94300000000001</c:v>
                </c:pt>
                <c:pt idx="51">
                  <c:v>138.43199999999999</c:v>
                </c:pt>
                <c:pt idx="52">
                  <c:v>136.68899999999999</c:v>
                </c:pt>
                <c:pt idx="53">
                  <c:v>134.964</c:v>
                </c:pt>
                <c:pt idx="54">
                  <c:v>137.589</c:v>
                </c:pt>
                <c:pt idx="55">
                  <c:v>135.977</c:v>
                </c:pt>
                <c:pt idx="56">
                  <c:v>131.44800000000001</c:v>
                </c:pt>
                <c:pt idx="57">
                  <c:v>128.11199999999999</c:v>
                </c:pt>
                <c:pt idx="58">
                  <c:v>126.584</c:v>
                </c:pt>
                <c:pt idx="59">
                  <c:v>120.932</c:v>
                </c:pt>
                <c:pt idx="60">
                  <c:v>121.006</c:v>
                </c:pt>
                <c:pt idx="61">
                  <c:v>144.93199999999999</c:v>
                </c:pt>
                <c:pt idx="62">
                  <c:v>159.96</c:v>
                </c:pt>
                <c:pt idx="63">
                  <c:v>170.124</c:v>
                </c:pt>
                <c:pt idx="64">
                  <c:v>172.535</c:v>
                </c:pt>
                <c:pt idx="65">
                  <c:v>167.233</c:v>
                </c:pt>
                <c:pt idx="66">
                  <c:v>158.852</c:v>
                </c:pt>
                <c:pt idx="67">
                  <c:v>143.36799999999999</c:v>
                </c:pt>
                <c:pt idx="68">
                  <c:v>130.715</c:v>
                </c:pt>
                <c:pt idx="69">
                  <c:v>131.70400000000001</c:v>
                </c:pt>
                <c:pt idx="70">
                  <c:v>137.517</c:v>
                </c:pt>
                <c:pt idx="71">
                  <c:v>134.52799999999999</c:v>
                </c:pt>
                <c:pt idx="72">
                  <c:v>126.375</c:v>
                </c:pt>
                <c:pt idx="73">
                  <c:v>120.111</c:v>
                </c:pt>
                <c:pt idx="74">
                  <c:v>119.858</c:v>
                </c:pt>
                <c:pt idx="75">
                  <c:v>122.82299999999999</c:v>
                </c:pt>
                <c:pt idx="76">
                  <c:v>137.19200000000001</c:v>
                </c:pt>
                <c:pt idx="77">
                  <c:v>146.637</c:v>
                </c:pt>
                <c:pt idx="78">
                  <c:v>153.483</c:v>
                </c:pt>
                <c:pt idx="79">
                  <c:v>156.14699999999999</c:v>
                </c:pt>
                <c:pt idx="80">
                  <c:v>154.36000000000001</c:v>
                </c:pt>
                <c:pt idx="81">
                  <c:v>150.233</c:v>
                </c:pt>
                <c:pt idx="82">
                  <c:v>141.17599999999999</c:v>
                </c:pt>
                <c:pt idx="83">
                  <c:v>134.601</c:v>
                </c:pt>
                <c:pt idx="84">
                  <c:v>134.30500000000001</c:v>
                </c:pt>
                <c:pt idx="85">
                  <c:v>138.358</c:v>
                </c:pt>
                <c:pt idx="86">
                  <c:v>133.953</c:v>
                </c:pt>
                <c:pt idx="87">
                  <c:v>134.69999999999999</c:v>
                </c:pt>
                <c:pt idx="88">
                  <c:v>132.53700000000001</c:v>
                </c:pt>
                <c:pt idx="89">
                  <c:v>130.739</c:v>
                </c:pt>
                <c:pt idx="90">
                  <c:v>103.735</c:v>
                </c:pt>
                <c:pt idx="91">
                  <c:v>133.18600000000001</c:v>
                </c:pt>
                <c:pt idx="92">
                  <c:v>142.69999999999999</c:v>
                </c:pt>
                <c:pt idx="93">
                  <c:v>147.55799999999999</c:v>
                </c:pt>
                <c:pt idx="94">
                  <c:v>148.46299999999999</c:v>
                </c:pt>
                <c:pt idx="95">
                  <c:v>144.94999999999999</c:v>
                </c:pt>
                <c:pt idx="96">
                  <c:v>135.72999999999999</c:v>
                </c:pt>
                <c:pt idx="97">
                  <c:v>119.20399999999999</c:v>
                </c:pt>
                <c:pt idx="98">
                  <c:v>118.57599999999999</c:v>
                </c:pt>
                <c:pt idx="99">
                  <c:v>124.992</c:v>
                </c:pt>
                <c:pt idx="100">
                  <c:v>127.795</c:v>
                </c:pt>
                <c:pt idx="101">
                  <c:v>126.06699999999999</c:v>
                </c:pt>
                <c:pt idx="102">
                  <c:v>115.46299999999999</c:v>
                </c:pt>
                <c:pt idx="103">
                  <c:v>113.548</c:v>
                </c:pt>
                <c:pt idx="104">
                  <c:v>113.432</c:v>
                </c:pt>
                <c:pt idx="105">
                  <c:v>127.634</c:v>
                </c:pt>
                <c:pt idx="106">
                  <c:v>129.358</c:v>
                </c:pt>
                <c:pt idx="107">
                  <c:v>128.232</c:v>
                </c:pt>
                <c:pt idx="108">
                  <c:v>124.539</c:v>
                </c:pt>
                <c:pt idx="109">
                  <c:v>122.24299999999999</c:v>
                </c:pt>
                <c:pt idx="110">
                  <c:v>119.80800000000001</c:v>
                </c:pt>
                <c:pt idx="111">
                  <c:v>120.822</c:v>
                </c:pt>
                <c:pt idx="112">
                  <c:v>120.551</c:v>
                </c:pt>
                <c:pt idx="113">
                  <c:v>122.232</c:v>
                </c:pt>
                <c:pt idx="114">
                  <c:v>124.42700000000001</c:v>
                </c:pt>
                <c:pt idx="115">
                  <c:v>127.099</c:v>
                </c:pt>
                <c:pt idx="116">
                  <c:v>126.872</c:v>
                </c:pt>
                <c:pt idx="117">
                  <c:v>128.733</c:v>
                </c:pt>
                <c:pt idx="118">
                  <c:v>137.26900000000001</c:v>
                </c:pt>
                <c:pt idx="135">
                  <c:v>100.07</c:v>
                </c:pt>
                <c:pt idx="136">
                  <c:v>103.905</c:v>
                </c:pt>
                <c:pt idx="137">
                  <c:v>104.572</c:v>
                </c:pt>
                <c:pt idx="138">
                  <c:v>106.012</c:v>
                </c:pt>
                <c:pt idx="139">
                  <c:v>107.07599999999999</c:v>
                </c:pt>
                <c:pt idx="140">
                  <c:v>106.973</c:v>
                </c:pt>
                <c:pt idx="141">
                  <c:v>106.822</c:v>
                </c:pt>
                <c:pt idx="142">
                  <c:v>104.70099999999999</c:v>
                </c:pt>
                <c:pt idx="143">
                  <c:v>105.21</c:v>
                </c:pt>
                <c:pt idx="144">
                  <c:v>109.18300000000001</c:v>
                </c:pt>
                <c:pt idx="145">
                  <c:v>110.139</c:v>
                </c:pt>
                <c:pt idx="146">
                  <c:v>114.46</c:v>
                </c:pt>
                <c:pt idx="147">
                  <c:v>111.919</c:v>
                </c:pt>
                <c:pt idx="148">
                  <c:v>111.73099999999999</c:v>
                </c:pt>
                <c:pt idx="150">
                  <c:v>102.46899999999999</c:v>
                </c:pt>
                <c:pt idx="151">
                  <c:v>106.31100000000001</c:v>
                </c:pt>
                <c:pt idx="152">
                  <c:v>106.34699999999999</c:v>
                </c:pt>
                <c:pt idx="153">
                  <c:v>105.04</c:v>
                </c:pt>
                <c:pt idx="154">
                  <c:v>103.53100000000001</c:v>
                </c:pt>
                <c:pt idx="155">
                  <c:v>101.663</c:v>
                </c:pt>
                <c:pt idx="156">
                  <c:v>97.269400000000005</c:v>
                </c:pt>
                <c:pt idx="157">
                  <c:v>91.795000000000002</c:v>
                </c:pt>
                <c:pt idx="158">
                  <c:v>90.648600000000002</c:v>
                </c:pt>
                <c:pt idx="159">
                  <c:v>88.6875</c:v>
                </c:pt>
                <c:pt idx="160">
                  <c:v>89.813699999999997</c:v>
                </c:pt>
                <c:pt idx="161">
                  <c:v>88.433499999999995</c:v>
                </c:pt>
                <c:pt idx="162">
                  <c:v>83.934299999999993</c:v>
                </c:pt>
                <c:pt idx="163">
                  <c:v>89.138000000000005</c:v>
                </c:pt>
                <c:pt idx="165">
                  <c:v>84.562299999999993</c:v>
                </c:pt>
                <c:pt idx="166">
                  <c:v>95.285700000000006</c:v>
                </c:pt>
                <c:pt idx="167">
                  <c:v>100.32899999999999</c:v>
                </c:pt>
                <c:pt idx="168">
                  <c:v>103.199</c:v>
                </c:pt>
                <c:pt idx="169">
                  <c:v>107.071</c:v>
                </c:pt>
                <c:pt idx="170">
                  <c:v>113.02</c:v>
                </c:pt>
                <c:pt idx="171">
                  <c:v>115.99</c:v>
                </c:pt>
                <c:pt idx="172">
                  <c:v>118.961</c:v>
                </c:pt>
                <c:pt idx="173">
                  <c:v>119.91200000000001</c:v>
                </c:pt>
                <c:pt idx="174">
                  <c:v>121.405</c:v>
                </c:pt>
                <c:pt idx="175">
                  <c:v>121.053</c:v>
                </c:pt>
                <c:pt idx="176">
                  <c:v>128.06100000000001</c:v>
                </c:pt>
                <c:pt idx="177">
                  <c:v>121.233</c:v>
                </c:pt>
                <c:pt idx="178">
                  <c:v>119.849</c:v>
                </c:pt>
                <c:pt idx="180">
                  <c:v>83.009200000000007</c:v>
                </c:pt>
                <c:pt idx="181">
                  <c:v>92.273300000000006</c:v>
                </c:pt>
                <c:pt idx="182">
                  <c:v>93.8643</c:v>
                </c:pt>
                <c:pt idx="183">
                  <c:v>95.558400000000006</c:v>
                </c:pt>
                <c:pt idx="184">
                  <c:v>95.558000000000007</c:v>
                </c:pt>
                <c:pt idx="185">
                  <c:v>94.849299999999999</c:v>
                </c:pt>
                <c:pt idx="186">
                  <c:v>92.649199999999993</c:v>
                </c:pt>
                <c:pt idx="187">
                  <c:v>91.016999999999996</c:v>
                </c:pt>
                <c:pt idx="188">
                  <c:v>93.599900000000005</c:v>
                </c:pt>
                <c:pt idx="189">
                  <c:v>93.546899999999994</c:v>
                </c:pt>
                <c:pt idx="190">
                  <c:v>95.414500000000004</c:v>
                </c:pt>
                <c:pt idx="191">
                  <c:v>90.166399999999996</c:v>
                </c:pt>
                <c:pt idx="192">
                  <c:v>94.235699999999994</c:v>
                </c:pt>
                <c:pt idx="195">
                  <c:v>120.327</c:v>
                </c:pt>
                <c:pt idx="196">
                  <c:v>124.321</c:v>
                </c:pt>
                <c:pt idx="197">
                  <c:v>128.089</c:v>
                </c:pt>
                <c:pt idx="198">
                  <c:v>130.172</c:v>
                </c:pt>
                <c:pt idx="199">
                  <c:v>131.886</c:v>
                </c:pt>
                <c:pt idx="200">
                  <c:v>134.506</c:v>
                </c:pt>
                <c:pt idx="201">
                  <c:v>135.26900000000001</c:v>
                </c:pt>
                <c:pt idx="202">
                  <c:v>127.372</c:v>
                </c:pt>
                <c:pt idx="203">
                  <c:v>121.84099999999999</c:v>
                </c:pt>
                <c:pt idx="204">
                  <c:v>122.175</c:v>
                </c:pt>
                <c:pt idx="205">
                  <c:v>126.4</c:v>
                </c:pt>
                <c:pt idx="206">
                  <c:v>139.49199999999999</c:v>
                </c:pt>
                <c:pt idx="207">
                  <c:v>145.1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CE5-4A95-8E38-2AE5725DAE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6642639"/>
        <c:axId val="1786302911"/>
      </c:scatterChart>
      <c:valAx>
        <c:axId val="1786642639"/>
        <c:scaling>
          <c:orientation val="minMax"/>
          <c:min val="7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Plasma glucose concentrations, m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86302911"/>
        <c:crosses val="autoZero"/>
        <c:crossBetween val="midCat"/>
      </c:valAx>
      <c:valAx>
        <c:axId val="1786302911"/>
        <c:scaling>
          <c:orientation val="minMax"/>
          <c:min val="7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Smoothed CGM data, m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866426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1353</cdr:x>
      <cdr:y>0.59183</cdr:y>
    </cdr:from>
    <cdr:to>
      <cdr:x>1</cdr:x>
      <cdr:y>0.71521</cdr:y>
    </cdr:to>
    <cdr:sp macro="" textlink="">
      <cdr:nvSpPr>
        <cdr:cNvPr id="2" name="ZoneTexte 1">
          <a:extLst xmlns:a="http://schemas.openxmlformats.org/drawingml/2006/main">
            <a:ext uri="{FF2B5EF4-FFF2-40B4-BE49-F238E27FC236}">
              <a16:creationId xmlns:a16="http://schemas.microsoft.com/office/drawing/2014/main" id="{84E68B19-F759-47B9-8EB9-1AC8F9FA2DA4}"/>
            </a:ext>
          </a:extLst>
        </cdr:cNvPr>
        <cdr:cNvSpPr txBox="1"/>
      </cdr:nvSpPr>
      <cdr:spPr>
        <a:xfrm xmlns:a="http://schemas.openxmlformats.org/drawingml/2006/main">
          <a:off x="3564884" y="1779858"/>
          <a:ext cx="1431235" cy="371061"/>
        </a:xfrm>
        <a:prstGeom xmlns:a="http://schemas.openxmlformats.org/drawingml/2006/main" prst="rect">
          <a:avLst/>
        </a:prstGeom>
        <a:ln xmlns:a="http://schemas.openxmlformats.org/drawingml/2006/main">
          <a:noFill/>
        </a:ln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 dirty="0"/>
            <a:t>r = 0.56, P &lt; 0. 01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60953-69A8-DB56-F7A8-B423598540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031763-2F08-DC56-F6CC-1728DBB9D7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0EB7C-9823-10A9-5CDA-023AC7822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B72990-534C-5F42-378E-85C3CF4A1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04F63E-06CE-ECA6-52CB-8BD02BA60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237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C321F-4186-1F57-9661-EFC9889A7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0AA85A-A6FC-7E68-8AC5-54B2ECEB91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ECB009-CFEA-D8B4-647E-0BDFDA0A3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C1465-32E5-321D-4E17-1E7F646BC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86E05-2AF9-169A-A77A-761DA9F73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35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7016D5-B1D1-12B5-20D0-81B9B5E2D2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58AB8E-D7C2-D88C-927C-B65DFF3884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C82DE7-617A-C065-4312-5CAA3FFFA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F0E8B1-D21D-A35F-FF8B-B6A9400E8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70755F-5088-9B96-9FE1-104DDFB29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48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2A004-9280-C73A-AB27-D25E2B5A4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FE6614-1D35-2567-2C41-754785CD58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FDE202-771E-7AA4-DDE3-5D455422C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C2FF5-D020-9CBF-FCDC-E75C9BFB7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C3228C-2EED-8962-0796-BCC03B8D4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795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3A0D9-DFF8-D4BD-BD30-C51C8E7708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BDF684-C172-3F4C-EDA6-81D7FDF7C4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A3115-5D8D-ED94-D589-B535BA283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0E5DE-1008-D8AD-D910-D5E5314A9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E13E22-2734-84D4-CC48-0F90ED8B0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441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CAC99-019E-1B4A-B378-76CC817B3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8B00C1-33C0-3930-4AFA-CDC7C4EE0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F5A8AF-0C37-0D33-AC80-767FE28B35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7554D8-FCF6-1A49-929C-BD0A08611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C37A6D-4973-7BEA-6FF0-482478973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CE07B4-3106-DCB6-7D97-B87EBD6E6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15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4A4FB-764C-23C8-7615-1D8CD84E69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EA102E-751D-CD4E-EBDB-0E10F0BC8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697FAD-233B-E0F2-70E4-F8ECA26C89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B8068F-9F1F-DE13-81A7-4F046428B3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4A74F3-0E68-F674-E797-C2D14ECCAD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07D3F8-7DC8-80FD-5A8D-DC617FDB2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21D62D-F941-F588-8B8E-856681BDD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D79076-3C50-F8E8-CD38-F7FA69E93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8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D17E7-6308-EDB8-DDA3-730E233DB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6C5DD9-0D0E-EF28-060F-30BC889B5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B9B016-1B1E-69AC-E357-34C78BDAA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1FC247-A700-D710-D2F8-EDF212C07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40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BB5462-5389-AEC2-8C02-049750D27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AB7F0-D513-C56B-C522-58BA4EDF7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78F3FE-A01D-9676-0193-DDCCF29DF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422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D4A89-933A-CFDD-6B3A-9428D6176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E4454C-28FF-FA15-58E7-547FE8E7AD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94B4E7-DDA5-2AC9-58E2-2F70E21D8F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A203F-3664-352D-3848-13C9BC731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2D81D-98B4-C29B-A696-F267AAE78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C2F87E-37F6-BA43-46E2-DBEC87850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737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BF263-8641-7E97-AEBD-4DD9ABC81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2EF1E3-0653-DE38-2898-E45DAEFA15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EB6C35-BCC9-A705-7A61-8AA042B44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02D00B-CA0B-F1FF-E36C-FC5E6FE50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56EBC3-0B90-C05B-C3E6-F4D808CD2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820478-12BD-A4F8-4C73-8D9A5199C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244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947F13-8AAE-ACCC-4A97-321D6F32D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764C6-9368-4F54-3E46-C1C252C75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3BC36-E6B8-84E3-8A50-4141476404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75DAA-C2A5-7B52-3A5D-B9EF149CC2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527DF-D9D9-E8A4-BBCF-374B9B32B9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654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5">
            <a:extLst>
              <a:ext uri="{FF2B5EF4-FFF2-40B4-BE49-F238E27FC236}">
                <a16:creationId xmlns:a16="http://schemas.microsoft.com/office/drawing/2014/main" id="{7CC19A29-F771-4C70-AC4B-94F0943D6485}"/>
              </a:ext>
            </a:extLst>
          </p:cNvPr>
          <p:cNvSpPr txBox="1"/>
          <p:nvPr/>
        </p:nvSpPr>
        <p:spPr>
          <a:xfrm>
            <a:off x="209184" y="8039639"/>
            <a:ext cx="6456658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Comparison between CGM readings and blood glucose concentrations 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 - Time-course variations of CGM readings compared to plasma glucose concentrations at regular time points just before and during 3 hours following the ingestion of a morning meal test, either rich in starch (HS diet) or rich in fat (HF diet).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 - Bland Altman analysis of raw CGM values vs blood glucose obtained at the same master time. The bias and extended 95% limits of agreement suggested that individual values of raw CGM data and time-matched plasma glucose concentrations cannot be compared pairwise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 - Bland Altman analysis of adjusted CGM values. When corrections (time delay and erythrocytes glucose transfer) were applied to CGM values, the pairwise comparison resulted in lower bias and reduced 95% limits of agreement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09DF8C3B-C680-4F2D-9FA6-866B6C83F9AC}"/>
              </a:ext>
            </a:extLst>
          </p:cNvPr>
          <p:cNvSpPr txBox="1"/>
          <p:nvPr/>
        </p:nvSpPr>
        <p:spPr>
          <a:xfrm>
            <a:off x="1369473" y="4498191"/>
            <a:ext cx="173316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as = -28.5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% limits of agreement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From -54.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To -2.8</a:t>
            </a:r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5672210E-0D6E-4AB3-A507-953F43601715}"/>
              </a:ext>
            </a:extLst>
          </p:cNvPr>
          <p:cNvSpPr txBox="1"/>
          <p:nvPr/>
        </p:nvSpPr>
        <p:spPr>
          <a:xfrm>
            <a:off x="4202750" y="4506371"/>
            <a:ext cx="173316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as = -24.6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% limits of agreement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From -71.8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To -22.4</a:t>
            </a:r>
          </a:p>
        </p:txBody>
      </p:sp>
      <p:pic>
        <p:nvPicPr>
          <p:cNvPr id="14" name="Picture 1">
            <a:extLst>
              <a:ext uri="{FF2B5EF4-FFF2-40B4-BE49-F238E27FC236}">
                <a16:creationId xmlns:a16="http://schemas.microsoft.com/office/drawing/2014/main" id="{1E9EC665-22A4-490A-B131-11A21021D1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4403" y="2776290"/>
            <a:ext cx="5783539" cy="212727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5A8B926-500A-4158-9CB3-CF3D8000992C}"/>
              </a:ext>
            </a:extLst>
          </p:cNvPr>
          <p:cNvSpPr txBox="1"/>
          <p:nvPr/>
        </p:nvSpPr>
        <p:spPr>
          <a:xfrm>
            <a:off x="540058" y="809509"/>
            <a:ext cx="463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9DA8CC7-8941-4058-BE3F-45F3578A01F6}"/>
              </a:ext>
            </a:extLst>
          </p:cNvPr>
          <p:cNvSpPr txBox="1"/>
          <p:nvPr/>
        </p:nvSpPr>
        <p:spPr>
          <a:xfrm>
            <a:off x="540058" y="2776570"/>
            <a:ext cx="463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17" name="Picture 4">
            <a:extLst>
              <a:ext uri="{FF2B5EF4-FFF2-40B4-BE49-F238E27FC236}">
                <a16:creationId xmlns:a16="http://schemas.microsoft.com/office/drawing/2014/main" id="{89A79B1B-8440-43E1-8F51-23959E6C51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403" y="5243831"/>
            <a:ext cx="6035113" cy="2592963"/>
          </a:xfrm>
          <a:prstGeom prst="rect">
            <a:avLst/>
          </a:prstGeom>
        </p:spPr>
      </p:pic>
      <p:sp>
        <p:nvSpPr>
          <p:cNvPr id="18" name="TextBox 7">
            <a:extLst>
              <a:ext uri="{FF2B5EF4-FFF2-40B4-BE49-F238E27FC236}">
                <a16:creationId xmlns:a16="http://schemas.microsoft.com/office/drawing/2014/main" id="{0D173E7B-6F56-419E-B770-EF77FC6B3E16}"/>
              </a:ext>
            </a:extLst>
          </p:cNvPr>
          <p:cNvSpPr txBox="1"/>
          <p:nvPr/>
        </p:nvSpPr>
        <p:spPr>
          <a:xfrm>
            <a:off x="1971108" y="7256245"/>
            <a:ext cx="28733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as = -5.7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5% limits of agreement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From -14.3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To -2.8</a:t>
            </a:r>
          </a:p>
        </p:txBody>
      </p:sp>
      <p:sp>
        <p:nvSpPr>
          <p:cNvPr id="19" name="Right Arrow 5">
            <a:extLst>
              <a:ext uri="{FF2B5EF4-FFF2-40B4-BE49-F238E27FC236}">
                <a16:creationId xmlns:a16="http://schemas.microsoft.com/office/drawing/2014/main" id="{9599068D-F7E8-4F27-9C3C-225C77993F99}"/>
              </a:ext>
            </a:extLst>
          </p:cNvPr>
          <p:cNvSpPr/>
          <p:nvPr/>
        </p:nvSpPr>
        <p:spPr>
          <a:xfrm>
            <a:off x="2098432" y="6367171"/>
            <a:ext cx="427592" cy="18745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0" name="Right Arrow 6">
            <a:extLst>
              <a:ext uri="{FF2B5EF4-FFF2-40B4-BE49-F238E27FC236}">
                <a16:creationId xmlns:a16="http://schemas.microsoft.com/office/drawing/2014/main" id="{1897BDB1-6346-4116-9C34-E2B38324D417}"/>
              </a:ext>
            </a:extLst>
          </p:cNvPr>
          <p:cNvSpPr/>
          <p:nvPr/>
        </p:nvSpPr>
        <p:spPr>
          <a:xfrm>
            <a:off x="4112050" y="6425702"/>
            <a:ext cx="427592" cy="18745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aphicFrame>
        <p:nvGraphicFramePr>
          <p:cNvPr id="15" name="Graphique 14">
            <a:extLst>
              <a:ext uri="{FF2B5EF4-FFF2-40B4-BE49-F238E27FC236}">
                <a16:creationId xmlns:a16="http://schemas.microsoft.com/office/drawing/2014/main" id="{EA7107D7-31E1-4391-BA5C-CA051CDB3C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1875836"/>
              </p:ext>
            </p:extLst>
          </p:nvPr>
        </p:nvGraphicFramePr>
        <p:xfrm>
          <a:off x="1074101" y="779997"/>
          <a:ext cx="4737125" cy="21272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1" name="ZoneTexte 20">
            <a:extLst>
              <a:ext uri="{FF2B5EF4-FFF2-40B4-BE49-F238E27FC236}">
                <a16:creationId xmlns:a16="http://schemas.microsoft.com/office/drawing/2014/main" id="{8A3D6DE4-FB6A-4296-9DB2-5B5F7ADA2E13}"/>
              </a:ext>
            </a:extLst>
          </p:cNvPr>
          <p:cNvSpPr txBox="1"/>
          <p:nvPr/>
        </p:nvSpPr>
        <p:spPr>
          <a:xfrm>
            <a:off x="610637" y="5114777"/>
            <a:ext cx="463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FCF72CF0-A1D4-4FC8-B58D-BCC2B33F498F}"/>
              </a:ext>
            </a:extLst>
          </p:cNvPr>
          <p:cNvSpPr txBox="1"/>
          <p:nvPr/>
        </p:nvSpPr>
        <p:spPr>
          <a:xfrm>
            <a:off x="437453" y="179334"/>
            <a:ext cx="6228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pilot study documenting nocturnal and diurnal glycemic excursions and their relationships in lean growing pigs fed contrasted diets 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4557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242</Words>
  <Application>Microsoft Office PowerPoint</Application>
  <PresentationFormat>Format A4 (210 x 297 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rles-Henri Malbert</dc:creator>
  <cp:lastModifiedBy>PHASE</cp:lastModifiedBy>
  <cp:revision>31</cp:revision>
  <dcterms:created xsi:type="dcterms:W3CDTF">2025-09-10T09:12:49Z</dcterms:created>
  <dcterms:modified xsi:type="dcterms:W3CDTF">2025-10-09T09:05:21Z</dcterms:modified>
</cp:coreProperties>
</file>